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68" y="15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8584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8086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6067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8134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744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9431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2034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9436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598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0115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9701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B0800-581A-434A-8401-8463C7911174}" type="datetimeFigureOut">
              <a:rPr lang="ko-KR" altLang="en-US" smtClean="0"/>
              <a:t>2023-08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E5EA0-D9CC-4955-AAF0-4F3B592567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9691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76540F-95D0-4AA4-BA92-22A84525042E}"/>
              </a:ext>
            </a:extLst>
          </p:cNvPr>
          <p:cNvSpPr txBox="1"/>
          <p:nvPr/>
        </p:nvSpPr>
        <p:spPr>
          <a:xfrm>
            <a:off x="517628" y="377072"/>
            <a:ext cx="2160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ull length western blot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8E458A4B-08E7-4045-9DD8-FEF7CEF1A4DF}"/>
              </a:ext>
            </a:extLst>
          </p:cNvPr>
          <p:cNvSpPr/>
          <p:nvPr/>
        </p:nvSpPr>
        <p:spPr>
          <a:xfrm>
            <a:off x="1007830" y="960422"/>
            <a:ext cx="23022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a-SMA  (42kDa / cell signaling  #19245s)</a:t>
            </a:r>
            <a:endParaRPr lang="ko-KR" altLang="en-US" sz="1000" b="1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84C3E7C7-8C98-4B84-8F4A-090ACDE5CC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7830" y="1269000"/>
            <a:ext cx="2532706" cy="2160000"/>
          </a:xfrm>
          <a:prstGeom prst="rect">
            <a:avLst/>
          </a:prstGeom>
        </p:spPr>
      </p:pic>
      <p:cxnSp>
        <p:nvCxnSpPr>
          <p:cNvPr id="6" name="직선 화살표 연결선 5">
            <a:extLst>
              <a:ext uri="{FF2B5EF4-FFF2-40B4-BE49-F238E27FC236}">
                <a16:creationId xmlns:a16="http://schemas.microsoft.com/office/drawing/2014/main" id="{9B1C1E05-5E45-40A3-8B98-D58B869F384E}"/>
              </a:ext>
            </a:extLst>
          </p:cNvPr>
          <p:cNvCxnSpPr>
            <a:cxnSpLocks/>
          </p:cNvCxnSpPr>
          <p:nvPr/>
        </p:nvCxnSpPr>
        <p:spPr>
          <a:xfrm>
            <a:off x="1169107" y="2085493"/>
            <a:ext cx="27291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직사각형 6">
            <a:extLst>
              <a:ext uri="{FF2B5EF4-FFF2-40B4-BE49-F238E27FC236}">
                <a16:creationId xmlns:a16="http://schemas.microsoft.com/office/drawing/2014/main" id="{F47CB53E-642A-4B86-8F26-91B293477D2B}"/>
              </a:ext>
            </a:extLst>
          </p:cNvPr>
          <p:cNvSpPr/>
          <p:nvPr/>
        </p:nvSpPr>
        <p:spPr>
          <a:xfrm>
            <a:off x="3266456" y="2032803"/>
            <a:ext cx="38504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/>
              <a:t>40kDa</a:t>
            </a:r>
            <a:endParaRPr lang="ko-KR" altLang="en-US" sz="800" b="1" dirty="0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3CEF8CBA-4540-4B4B-829F-E012550BB4E1}"/>
              </a:ext>
            </a:extLst>
          </p:cNvPr>
          <p:cNvSpPr/>
          <p:nvPr/>
        </p:nvSpPr>
        <p:spPr>
          <a:xfrm>
            <a:off x="3266456" y="2155941"/>
            <a:ext cx="38504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/>
              <a:t>35kDa</a:t>
            </a:r>
            <a:endParaRPr lang="ko-KR" altLang="en-US" sz="800" b="1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814E81EA-406A-475D-87D0-A32985AE1EC8}"/>
              </a:ext>
            </a:extLst>
          </p:cNvPr>
          <p:cNvSpPr/>
          <p:nvPr/>
        </p:nvSpPr>
        <p:spPr>
          <a:xfrm>
            <a:off x="3267036" y="1851498"/>
            <a:ext cx="38504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00" b="1" dirty="0"/>
              <a:t>50kDa</a:t>
            </a:r>
            <a:endParaRPr lang="ko-KR" altLang="en-US" sz="800" b="1" dirty="0"/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47255F15-E3C7-45D7-AB85-D77DD21DF9CA}"/>
              </a:ext>
            </a:extLst>
          </p:cNvPr>
          <p:cNvSpPr/>
          <p:nvPr/>
        </p:nvSpPr>
        <p:spPr>
          <a:xfrm>
            <a:off x="4487919" y="1003956"/>
            <a:ext cx="22733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GAPDH  (37kDa / cell signaling  #5174s)</a:t>
            </a:r>
            <a:endParaRPr lang="ko-KR" altLang="en-US" sz="1000" b="1" dirty="0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6F3F4496-AA4B-45FF-A0C9-89D1BFD60CF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7" t="17475" r="30781" b="31009"/>
          <a:stretch/>
        </p:blipFill>
        <p:spPr>
          <a:xfrm>
            <a:off x="4572000" y="1206643"/>
            <a:ext cx="2273379" cy="2159001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6499FD98-3861-4DA5-B905-FE0D2A4DD426}"/>
              </a:ext>
            </a:extLst>
          </p:cNvPr>
          <p:cNvSpPr/>
          <p:nvPr/>
        </p:nvSpPr>
        <p:spPr>
          <a:xfrm>
            <a:off x="6636027" y="1973160"/>
            <a:ext cx="41870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700" b="1" dirty="0"/>
              <a:t>40kDa</a:t>
            </a:r>
            <a:endParaRPr lang="ko-KR" altLang="en-US" sz="900" b="1" dirty="0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99FEDE77-85AC-424E-A77B-2D4AD19230BC}"/>
              </a:ext>
            </a:extLst>
          </p:cNvPr>
          <p:cNvSpPr/>
          <p:nvPr/>
        </p:nvSpPr>
        <p:spPr>
          <a:xfrm>
            <a:off x="6636027" y="2086089"/>
            <a:ext cx="41870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700" b="1" dirty="0"/>
              <a:t>35kDa</a:t>
            </a:r>
            <a:endParaRPr lang="ko-KR" altLang="en-US" sz="900" b="1" dirty="0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9A0909EB-AE60-4071-AFE7-757156F9F4E7}"/>
              </a:ext>
            </a:extLst>
          </p:cNvPr>
          <p:cNvSpPr/>
          <p:nvPr/>
        </p:nvSpPr>
        <p:spPr>
          <a:xfrm>
            <a:off x="6637071" y="1806987"/>
            <a:ext cx="41870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700" b="1" dirty="0"/>
              <a:t>50kDa</a:t>
            </a:r>
            <a:endParaRPr lang="ko-KR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1712807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on-Seung</dc:creator>
  <cp:lastModifiedBy>Hyon-Seung</cp:lastModifiedBy>
  <cp:revision>2</cp:revision>
  <dcterms:created xsi:type="dcterms:W3CDTF">2023-08-04T00:27:04Z</dcterms:created>
  <dcterms:modified xsi:type="dcterms:W3CDTF">2023-08-07T08:46:49Z</dcterms:modified>
</cp:coreProperties>
</file>